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4" r:id="rId2"/>
  </p:sldIdLst>
  <p:sldSz cx="9144000" cy="6858000" type="screen4x3"/>
  <p:notesSz cx="6797675" cy="9928225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342" y="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C4A77B-6283-4730-BC35-91550FBFC96C}" type="datetimeFigureOut">
              <a:rPr lang="en-US" smtClean="0"/>
              <a:t>1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AC3CCF-6B98-4EF6-BB44-125CA4232D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40861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FC37AB-B8FC-470D-B252-BE2130B17F5D}" type="datetimeFigureOut">
              <a:rPr lang="en-US" smtClean="0"/>
              <a:t>1/2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B9785C-D423-45BB-A6D4-2A9574A32B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7148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5C8761-A422-401C-934F-DBB434D69F50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496F16-8245-4CC6-B49A-CA3E3A46380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71CE55-6C7D-4145-8460-9AD6D3679E1A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36B242-A357-4C6A-8CF1-B3F5C74775C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93D18F-C672-499C-8F87-19232F6E6709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AC726E-0186-4A77-97B7-F45801C04DE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80F586-8630-49BB-8DF2-F3F42D033278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D1C440-DEBD-496C-BFDD-5CC6DA0A71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8D108B-CC42-4EC1-97B6-602A037E04CE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B7E995-D04A-458D-A2B8-EB0DD53F0C2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17BCEF-2346-4706-A4EB-A6E714A2D318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F4B1D9-8E9A-4794-8D91-0428B304400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C283F5-7672-4CA6-B4C5-02C42780DFD5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6EE5E1-2B6E-4C7F-8984-CAA8CECAAF4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1667B2-222A-4613-B5FD-AFF51622079D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345384-5FD2-4804-B082-19F88AF9988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8AFD0A-1B8D-4B43-B27D-834DEA511307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CF406C-30C0-4708-A53A-6DA1084107D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16F876-A80F-4237-96C7-029811984924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B0E952-FD0B-4713-8FC1-C76196ECD0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3996F7-9BFF-4EF4-97A2-72E097AE9F9C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FBF5A2-3AF0-401F-AAAE-86AFA84729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DE5559E7-C590-4B48-8F91-8FF7791530FB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8AC322C4-652A-466C-B9B6-4BC3DA09997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123" charset="-128"/>
          <a:cs typeface="ＭＳ Ｐゴシック" pitchFamily="-123" charset="-128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pitchFamily="-123" charset="0"/>
        <a:buChar char="•"/>
        <a:defRPr sz="3200" kern="1200">
          <a:solidFill>
            <a:schemeClr val="tx1"/>
          </a:solidFill>
          <a:latin typeface="+mn-lt"/>
          <a:ea typeface="ＭＳ Ｐゴシック" pitchFamily="-123" charset="-128"/>
          <a:cs typeface="ＭＳ Ｐゴシック" pitchFamily="-123" charset="-128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pitchFamily="-123" charset="0"/>
        <a:buChar char="–"/>
        <a:defRPr sz="28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•"/>
        <a:defRPr sz="24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–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»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175" y="1398124"/>
            <a:ext cx="3005295" cy="214033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0383" y="1439806"/>
            <a:ext cx="2843599" cy="209705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9753" y="1456919"/>
            <a:ext cx="2558364" cy="2304919"/>
          </a:xfrm>
          <a:prstGeom prst="rect">
            <a:avLst/>
          </a:prstGeom>
        </p:spPr>
      </p:pic>
      <p:grpSp>
        <p:nvGrpSpPr>
          <p:cNvPr id="7" name="Group 6"/>
          <p:cNvGrpSpPr/>
          <p:nvPr/>
        </p:nvGrpSpPr>
        <p:grpSpPr>
          <a:xfrm>
            <a:off x="107504" y="3680120"/>
            <a:ext cx="2865055" cy="2133010"/>
            <a:chOff x="5335601" y="1917369"/>
            <a:chExt cx="2865055" cy="2133010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455" t="8626" r="3997" b="11199"/>
            <a:stretch/>
          </p:blipFill>
          <p:spPr>
            <a:xfrm>
              <a:off x="6089466" y="2799850"/>
              <a:ext cx="1378134" cy="1250529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5357330" y="3727367"/>
              <a:ext cx="7646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Tubulin</a:t>
              </a:r>
              <a:endParaRPr lang="zh-HK" altLang="en-US" sz="14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335601" y="3399696"/>
              <a:ext cx="80182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FOXM1</a:t>
              </a:r>
              <a:endParaRPr lang="zh-HK" altLang="en-US" sz="14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595796" y="3083176"/>
              <a:ext cx="53732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ER</a:t>
              </a:r>
              <a:r>
                <a:rPr lang="el-GR" altLang="zh-HK" sz="1400" dirty="0">
                  <a:latin typeface="Minion Pro Med" panose="02040503050201020203" pitchFamily="18" charset="0"/>
                </a:rPr>
                <a:t>α</a:t>
              </a:r>
              <a:endParaRPr lang="zh-HK" altLang="en-US" sz="14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466272" y="2778379"/>
              <a:ext cx="6623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eIF4E</a:t>
              </a:r>
              <a:endParaRPr lang="zh-HK" altLang="en-US" sz="1400" dirty="0"/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6028454" y="2374198"/>
              <a:ext cx="5934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 err="1"/>
                <a:t>siCtrl</a:t>
              </a:r>
              <a:endParaRPr lang="zh-HK" altLang="en-US" sz="1400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7446907" y="3104295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66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7446907" y="2799278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25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7446255" y="3737781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55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7362478" y="3424836"/>
              <a:ext cx="8381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10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25" name="TextBox 24"/>
            <p:cNvSpPr txBox="1"/>
            <p:nvPr/>
          </p:nvSpPr>
          <p:spPr>
            <a:xfrm rot="16200000">
              <a:off x="6312324" y="2210077"/>
              <a:ext cx="8931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siRNA#1</a:t>
              </a:r>
              <a:endParaRPr lang="zh-HK" altLang="en-US" sz="1400" dirty="0"/>
            </a:p>
          </p:txBody>
        </p:sp>
        <p:sp>
          <p:nvSpPr>
            <p:cNvPr id="26" name="TextBox 25"/>
            <p:cNvSpPr txBox="1"/>
            <p:nvPr/>
          </p:nvSpPr>
          <p:spPr>
            <a:xfrm rot="16200000">
              <a:off x="6757799" y="2210078"/>
              <a:ext cx="8931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siRNA#2</a:t>
              </a:r>
              <a:endParaRPr lang="zh-HK" altLang="en-US" sz="1400" dirty="0"/>
            </a:p>
          </p:txBody>
        </p:sp>
      </p:grpSp>
      <p:grpSp>
        <p:nvGrpSpPr>
          <p:cNvPr id="27" name="Group 26"/>
          <p:cNvGrpSpPr/>
          <p:nvPr/>
        </p:nvGrpSpPr>
        <p:grpSpPr>
          <a:xfrm>
            <a:off x="3096666" y="3681961"/>
            <a:ext cx="2930576" cy="2141779"/>
            <a:chOff x="5304670" y="1249158"/>
            <a:chExt cx="2930576" cy="2141779"/>
          </a:xfrm>
        </p:grpSpPr>
        <p:pic>
          <p:nvPicPr>
            <p:cNvPr id="28" name="Picture 27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146" t="8360" r="5988" b="11274"/>
            <a:stretch/>
          </p:blipFill>
          <p:spPr>
            <a:xfrm>
              <a:off x="6096758" y="2157710"/>
              <a:ext cx="1382565" cy="1217860"/>
            </a:xfrm>
            <a:prstGeom prst="rect">
              <a:avLst/>
            </a:prstGeom>
          </p:spPr>
        </p:pic>
        <p:sp>
          <p:nvSpPr>
            <p:cNvPr id="29" name="TextBox 28"/>
            <p:cNvSpPr txBox="1"/>
            <p:nvPr/>
          </p:nvSpPr>
          <p:spPr>
            <a:xfrm>
              <a:off x="5353843" y="3083160"/>
              <a:ext cx="7646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Tubulin</a:t>
              </a:r>
              <a:endParaRPr lang="zh-HK" altLang="en-US" sz="1400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5304670" y="2766640"/>
              <a:ext cx="80182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FOXM1</a:t>
              </a:r>
              <a:endParaRPr lang="zh-HK" altLang="en-US" sz="1400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596512" y="2143087"/>
              <a:ext cx="53732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ER</a:t>
              </a:r>
              <a:r>
                <a:rPr lang="el-GR" altLang="zh-HK" sz="1400" dirty="0">
                  <a:latin typeface="Minion Pro Med" panose="02040503050201020203" pitchFamily="18" charset="0"/>
                </a:rPr>
                <a:t>α</a:t>
              </a:r>
              <a:endParaRPr lang="zh-HK" altLang="en-US" sz="14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5480795" y="2438397"/>
              <a:ext cx="6623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eIF4E</a:t>
              </a:r>
              <a:endParaRPr lang="zh-HK" altLang="en-US" sz="1400" dirty="0"/>
            </a:p>
          </p:txBody>
        </p:sp>
        <p:sp>
          <p:nvSpPr>
            <p:cNvPr id="36" name="TextBox 35"/>
            <p:cNvSpPr txBox="1"/>
            <p:nvPr/>
          </p:nvSpPr>
          <p:spPr>
            <a:xfrm rot="16200000">
              <a:off x="6028454" y="1705987"/>
              <a:ext cx="5934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 err="1"/>
                <a:t>siCtrl</a:t>
              </a:r>
              <a:endParaRPr lang="zh-HK" altLang="en-US" sz="1400" dirty="0"/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6312324" y="1541866"/>
              <a:ext cx="8931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siRNA#1</a:t>
              </a:r>
              <a:endParaRPr lang="zh-HK" altLang="en-US" sz="1400" dirty="0"/>
            </a:p>
          </p:txBody>
        </p:sp>
        <p:sp>
          <p:nvSpPr>
            <p:cNvPr id="42" name="TextBox 41"/>
            <p:cNvSpPr txBox="1"/>
            <p:nvPr/>
          </p:nvSpPr>
          <p:spPr>
            <a:xfrm rot="16200000">
              <a:off x="6757799" y="1541867"/>
              <a:ext cx="8931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siRNA#2</a:t>
              </a:r>
              <a:endParaRPr lang="zh-HK" altLang="en-US" sz="1400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7476785" y="2125495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66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7483117" y="2426575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25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7482465" y="3060280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55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7387537" y="2747335"/>
              <a:ext cx="8381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10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</p:grpSp>
      <p:grpSp>
        <p:nvGrpSpPr>
          <p:cNvPr id="47" name="Group 46"/>
          <p:cNvGrpSpPr/>
          <p:nvPr/>
        </p:nvGrpSpPr>
        <p:grpSpPr>
          <a:xfrm>
            <a:off x="6082843" y="3679553"/>
            <a:ext cx="2799313" cy="2193227"/>
            <a:chOff x="5025149" y="1050486"/>
            <a:chExt cx="2799313" cy="2193227"/>
          </a:xfrm>
        </p:grpSpPr>
        <p:pic>
          <p:nvPicPr>
            <p:cNvPr id="48" name="Picture 47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376" t="9062" r="3325" b="9382"/>
            <a:stretch/>
          </p:blipFill>
          <p:spPr>
            <a:xfrm>
              <a:off x="5730770" y="1934308"/>
              <a:ext cx="1361692" cy="1309405"/>
            </a:xfrm>
            <a:prstGeom prst="rect">
              <a:avLst/>
            </a:prstGeom>
          </p:spPr>
        </p:pic>
        <p:sp>
          <p:nvSpPr>
            <p:cNvPr id="49" name="TextBox 48"/>
            <p:cNvSpPr txBox="1"/>
            <p:nvPr/>
          </p:nvSpPr>
          <p:spPr>
            <a:xfrm>
              <a:off x="5058029" y="2908978"/>
              <a:ext cx="7646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Tubulin</a:t>
              </a:r>
              <a:endParaRPr lang="zh-HK" altLang="en-US" sz="14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5025149" y="1958839"/>
              <a:ext cx="80182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FOXM1</a:t>
              </a:r>
              <a:endParaRPr lang="zh-HK" altLang="en-US" sz="14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5272387" y="2613670"/>
              <a:ext cx="53732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ER</a:t>
              </a:r>
              <a:r>
                <a:rPr lang="el-GR" altLang="zh-HK" sz="1400" dirty="0">
                  <a:latin typeface="Minion Pro Med" panose="02040503050201020203" pitchFamily="18" charset="0"/>
                </a:rPr>
                <a:t>α</a:t>
              </a:r>
              <a:endParaRPr lang="zh-HK" altLang="en-US" sz="14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5156670" y="2299384"/>
              <a:ext cx="6623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eIF4E</a:t>
              </a:r>
              <a:endParaRPr lang="zh-HK" altLang="en-US" sz="1400" dirty="0"/>
            </a:p>
          </p:txBody>
        </p:sp>
        <p:sp>
          <p:nvSpPr>
            <p:cNvPr id="56" name="TextBox 55"/>
            <p:cNvSpPr txBox="1"/>
            <p:nvPr/>
          </p:nvSpPr>
          <p:spPr>
            <a:xfrm rot="16200000">
              <a:off x="5640636" y="1507315"/>
              <a:ext cx="5934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 err="1"/>
                <a:t>siCtrl</a:t>
              </a:r>
              <a:endParaRPr lang="zh-HK" altLang="en-US" sz="1400" dirty="0"/>
            </a:p>
          </p:txBody>
        </p:sp>
        <p:sp>
          <p:nvSpPr>
            <p:cNvPr id="61" name="TextBox 60"/>
            <p:cNvSpPr txBox="1"/>
            <p:nvPr/>
          </p:nvSpPr>
          <p:spPr>
            <a:xfrm rot="16200000">
              <a:off x="5924506" y="1343194"/>
              <a:ext cx="8931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siRNA#1</a:t>
              </a:r>
              <a:endParaRPr lang="zh-HK" altLang="en-US" sz="1400" dirty="0"/>
            </a:p>
          </p:txBody>
        </p:sp>
        <p:sp>
          <p:nvSpPr>
            <p:cNvPr id="62" name="TextBox 61"/>
            <p:cNvSpPr txBox="1"/>
            <p:nvPr/>
          </p:nvSpPr>
          <p:spPr>
            <a:xfrm rot="16200000">
              <a:off x="6369981" y="1343195"/>
              <a:ext cx="8931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siRNA#2</a:t>
              </a:r>
              <a:endParaRPr lang="zh-HK" altLang="en-US" sz="1400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7066001" y="2586023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66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7072333" y="2254061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25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7071681" y="2922935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55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6976753" y="1930052"/>
              <a:ext cx="8381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10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</p:grpSp>
      <p:sp>
        <p:nvSpPr>
          <p:cNvPr id="53" name="TextBox 52"/>
          <p:cNvSpPr txBox="1"/>
          <p:nvPr/>
        </p:nvSpPr>
        <p:spPr>
          <a:xfrm>
            <a:off x="251520" y="83671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a</a:t>
            </a:r>
            <a:endParaRPr lang="en-US" dirty="0"/>
          </a:p>
        </p:txBody>
      </p:sp>
      <p:sp>
        <p:nvSpPr>
          <p:cNvPr id="54" name="TextBox 53"/>
          <p:cNvSpPr txBox="1"/>
          <p:nvPr/>
        </p:nvSpPr>
        <p:spPr>
          <a:xfrm>
            <a:off x="3153326" y="83671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c</a:t>
            </a:r>
            <a:endParaRPr lang="en-US" dirty="0"/>
          </a:p>
        </p:txBody>
      </p:sp>
      <p:sp>
        <p:nvSpPr>
          <p:cNvPr id="55" name="TextBox 54"/>
          <p:cNvSpPr txBox="1"/>
          <p:nvPr/>
        </p:nvSpPr>
        <p:spPr>
          <a:xfrm>
            <a:off x="6105654" y="83671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e</a:t>
            </a:r>
            <a:endParaRPr lang="en-US" dirty="0"/>
          </a:p>
        </p:txBody>
      </p:sp>
      <p:sp>
        <p:nvSpPr>
          <p:cNvPr id="57" name="TextBox 56"/>
          <p:cNvSpPr txBox="1"/>
          <p:nvPr/>
        </p:nvSpPr>
        <p:spPr>
          <a:xfrm>
            <a:off x="251520" y="363573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b</a:t>
            </a:r>
            <a:endParaRPr lang="en-US" dirty="0"/>
          </a:p>
        </p:txBody>
      </p:sp>
      <p:sp>
        <p:nvSpPr>
          <p:cNvPr id="58" name="TextBox 57"/>
          <p:cNvSpPr txBox="1"/>
          <p:nvPr/>
        </p:nvSpPr>
        <p:spPr>
          <a:xfrm>
            <a:off x="3153326" y="363573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d</a:t>
            </a:r>
            <a:endParaRPr lang="en-US" dirty="0"/>
          </a:p>
        </p:txBody>
      </p:sp>
      <p:sp>
        <p:nvSpPr>
          <p:cNvPr id="59" name="TextBox 58"/>
          <p:cNvSpPr txBox="1"/>
          <p:nvPr/>
        </p:nvSpPr>
        <p:spPr>
          <a:xfrm>
            <a:off x="6105654" y="3635732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f</a:t>
            </a:r>
            <a:endParaRPr lang="en-US" dirty="0"/>
          </a:p>
        </p:txBody>
      </p:sp>
      <p:sp>
        <p:nvSpPr>
          <p:cNvPr id="67" name="TextBox 66"/>
          <p:cNvSpPr txBox="1"/>
          <p:nvPr/>
        </p:nvSpPr>
        <p:spPr>
          <a:xfrm>
            <a:off x="44712" y="46365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zh-HK" dirty="0"/>
              <a:t>Figure S</a:t>
            </a:r>
            <a:r>
              <a:rPr lang="en-US" altLang="zh-TW" dirty="0"/>
              <a:t>7</a:t>
            </a:r>
            <a:endParaRPr lang="en-GB" altLang="zh-HK" dirty="0"/>
          </a:p>
        </p:txBody>
      </p:sp>
    </p:spTree>
    <p:extLst>
      <p:ext uri="{BB962C8B-B14F-4D97-AF65-F5344CB8AC3E}">
        <p14:creationId xmlns:p14="http://schemas.microsoft.com/office/powerpoint/2010/main" val="5782745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07</TotalTime>
  <Words>57</Words>
  <Application>Microsoft Office PowerPoint</Application>
  <PresentationFormat>On-screen Show (4:3)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Minion Pro Med</vt:lpstr>
      <vt:lpstr>Office Theme</vt:lpstr>
      <vt:lpstr>PowerPoint Presentation</vt:lpstr>
    </vt:vector>
  </TitlesOfParts>
  <Company>The University of Hong Kon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Tsoi Ho</dc:creator>
  <cp:lastModifiedBy>Windows User</cp:lastModifiedBy>
  <cp:revision>103</cp:revision>
  <cp:lastPrinted>2019-05-24T08:26:42Z</cp:lastPrinted>
  <dcterms:created xsi:type="dcterms:W3CDTF">2017-10-03T01:31:32Z</dcterms:created>
  <dcterms:modified xsi:type="dcterms:W3CDTF">2020-01-29T02:59:29Z</dcterms:modified>
</cp:coreProperties>
</file>